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howGuides="1">
      <p:cViewPr varScale="1">
        <p:scale>
          <a:sx n="99" d="100"/>
          <a:sy n="99" d="100"/>
        </p:scale>
        <p:origin x="-240" y="-102"/>
      </p:cViewPr>
      <p:guideLst>
        <p:guide orient="horz" pos="2160"/>
        <p:guide pos="5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2774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501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615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893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79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98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106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296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353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180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750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BA33A-B4D9-46C4-9D94-E9450AC4B464}" type="datetimeFigureOut">
              <a:rPr lang="en-GB" smtClean="0"/>
              <a:t>2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18445-0502-4274-B009-FCD4F8C4F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0824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34" Type="http://schemas.openxmlformats.org/officeDocument/2006/relationships/image" Target="../media/image33.em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emf"/><Relationship Id="rId33" Type="http://schemas.openxmlformats.org/officeDocument/2006/relationships/image" Target="../media/image32.emf"/><Relationship Id="rId38" Type="http://schemas.openxmlformats.org/officeDocument/2006/relationships/image" Target="../media/image37.emf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emf"/><Relationship Id="rId32" Type="http://schemas.openxmlformats.org/officeDocument/2006/relationships/image" Target="../media/image31.emf"/><Relationship Id="rId37" Type="http://schemas.openxmlformats.org/officeDocument/2006/relationships/image" Target="../media/image36.emf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36" Type="http://schemas.openxmlformats.org/officeDocument/2006/relationships/image" Target="../media/image35.emf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emf"/><Relationship Id="rId4" Type="http://schemas.openxmlformats.org/officeDocument/2006/relationships/image" Target="../media/image3.emf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emf"/><Relationship Id="rId27" Type="http://schemas.openxmlformats.org/officeDocument/2006/relationships/image" Target="../media/image26.emf"/><Relationship Id="rId30" Type="http://schemas.openxmlformats.org/officeDocument/2006/relationships/image" Target="../media/image29.emf"/><Relationship Id="rId35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0587" y="978198"/>
            <a:ext cx="2616077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921" y="978198"/>
            <a:ext cx="2621495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824963" y="2463451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25363" y="2471645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47"/>
          <p:cNvSpPr txBox="1">
            <a:spLocks noChangeArrowheads="1"/>
          </p:cNvSpPr>
          <p:nvPr/>
        </p:nvSpPr>
        <p:spPr bwMode="auto">
          <a:xfrm rot="16200000">
            <a:off x="-179520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9" name="TextBox 47"/>
          <p:cNvSpPr txBox="1">
            <a:spLocks noChangeArrowheads="1"/>
          </p:cNvSpPr>
          <p:nvPr/>
        </p:nvSpPr>
        <p:spPr bwMode="auto">
          <a:xfrm rot="16200000">
            <a:off x="3038726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10" name="TextBox 173"/>
          <p:cNvSpPr txBox="1">
            <a:spLocks noChangeArrowheads="1"/>
          </p:cNvSpPr>
          <p:nvPr/>
        </p:nvSpPr>
        <p:spPr bwMode="auto">
          <a:xfrm>
            <a:off x="4596876" y="2014640"/>
            <a:ext cx="121934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11" name="TextBox 166"/>
          <p:cNvSpPr txBox="1">
            <a:spLocks noChangeArrowheads="1"/>
          </p:cNvSpPr>
          <p:nvPr/>
        </p:nvSpPr>
        <p:spPr bwMode="auto">
          <a:xfrm>
            <a:off x="5758430" y="1116224"/>
            <a:ext cx="121934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12" name="TextBox 173"/>
          <p:cNvSpPr txBox="1">
            <a:spLocks noChangeArrowheads="1"/>
          </p:cNvSpPr>
          <p:nvPr/>
        </p:nvSpPr>
        <p:spPr bwMode="auto">
          <a:xfrm>
            <a:off x="2428261" y="1055334"/>
            <a:ext cx="121934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13" name="TextBox 166"/>
          <p:cNvSpPr txBox="1">
            <a:spLocks noChangeArrowheads="1"/>
          </p:cNvSpPr>
          <p:nvPr/>
        </p:nvSpPr>
        <p:spPr bwMode="auto">
          <a:xfrm>
            <a:off x="2616686" y="1055334"/>
            <a:ext cx="121934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75671" y="100704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A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3852481" y="1038939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GB" sz="12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3881448" y="-92607"/>
            <a:ext cx="3512807" cy="1111631"/>
            <a:chOff x="3837649" y="-135184"/>
            <a:chExt cx="3512807" cy="1111631"/>
          </a:xfrm>
        </p:grpSpPr>
        <p:sp>
          <p:nvSpPr>
            <p:cNvPr id="17" name="TextBox 16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ERK</a:t>
              </a:r>
              <a:endParaRPr lang="en-GB" sz="1200" dirty="0"/>
            </a:p>
          </p:txBody>
        </p:sp>
        <p:pic>
          <p:nvPicPr>
            <p:cNvPr id="19" name="Picture 5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7649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6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12375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7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9972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" name="Picture 8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7284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" name="Picture 9"/>
            <p:cNvPicPr preferRelativeResize="0">
              <a:picLocks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14738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10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2192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25"/>
            <p:cNvPicPr preferRelativeResize="0">
              <a:picLocks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49646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6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17100" y="800464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661491" y="-76810"/>
            <a:ext cx="3482845" cy="1099606"/>
            <a:chOff x="681722" y="-150673"/>
            <a:chExt cx="3482845" cy="1099606"/>
          </a:xfrm>
        </p:grpSpPr>
        <p:pic>
          <p:nvPicPr>
            <p:cNvPr id="35" name="Picture 20"/>
            <p:cNvPicPr preferRelativeResize="0"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2186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21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7639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18"/>
            <p:cNvPicPr preferRelativeResize="0">
              <a:picLocks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1722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19"/>
            <p:cNvPicPr preferRelativeResize="0">
              <a:picLocks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52730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9" name="Picture 22"/>
            <p:cNvPicPr preferRelativeResize="0">
              <a:picLocks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44805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0" name="Picture 23"/>
            <p:cNvPicPr preferRelativeResize="0">
              <a:picLocks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7512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" name="Picture 27"/>
            <p:cNvPicPr preferRelativeResize="0">
              <a:picLocks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90001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28"/>
            <p:cNvPicPr preferRelativeResize="0">
              <a:picLocks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2764" y="769768"/>
              <a:ext cx="228600" cy="1188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TextBox 42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ERK</a:t>
              </a:r>
              <a:endParaRPr lang="en-GB" sz="1200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6156998" y="1122195"/>
            <a:ext cx="730215" cy="384578"/>
            <a:chOff x="6156998" y="1122195"/>
            <a:chExt cx="730215" cy="384578"/>
          </a:xfrm>
        </p:grpSpPr>
        <p:sp>
          <p:nvSpPr>
            <p:cNvPr id="53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54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/>
          <p:cNvSpPr txBox="1"/>
          <p:nvPr/>
        </p:nvSpPr>
        <p:spPr>
          <a:xfrm>
            <a:off x="726504" y="1030046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Left Ventricle</a:t>
            </a:r>
            <a:endParaRPr lang="en-US" sz="1000" dirty="0"/>
          </a:p>
        </p:txBody>
      </p:sp>
      <p:sp>
        <p:nvSpPr>
          <p:cNvPr id="58" name="TextBox 57"/>
          <p:cNvSpPr txBox="1"/>
          <p:nvPr/>
        </p:nvSpPr>
        <p:spPr>
          <a:xfrm>
            <a:off x="3994827" y="1066800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Left Ventricle</a:t>
            </a:r>
            <a:endParaRPr lang="en-US" sz="1000" dirty="0"/>
          </a:p>
        </p:txBody>
      </p:sp>
      <p:pic>
        <p:nvPicPr>
          <p:cNvPr id="59" name="Picture 2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3552" y="3443918"/>
            <a:ext cx="265927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59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3443918"/>
            <a:ext cx="264041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817272" y="4917107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2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51985" y="4917260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TextBox 47"/>
          <p:cNvSpPr txBox="1">
            <a:spLocks noChangeArrowheads="1"/>
          </p:cNvSpPr>
          <p:nvPr/>
        </p:nvSpPr>
        <p:spPr bwMode="auto">
          <a:xfrm rot="16200000">
            <a:off x="-156578" y="38685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4" name="TextBox 47"/>
          <p:cNvSpPr txBox="1">
            <a:spLocks noChangeArrowheads="1"/>
          </p:cNvSpPr>
          <p:nvPr/>
        </p:nvSpPr>
        <p:spPr bwMode="auto">
          <a:xfrm rot="16200000">
            <a:off x="3042418" y="38685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71900" y="345250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</a:t>
            </a:r>
            <a:endParaRPr lang="en-GB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3904298" y="345250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  <a:endParaRPr lang="en-GB" sz="1200" dirty="0"/>
          </a:p>
        </p:txBody>
      </p:sp>
      <p:grpSp>
        <p:nvGrpSpPr>
          <p:cNvPr id="67" name="Group 66"/>
          <p:cNvGrpSpPr/>
          <p:nvPr/>
        </p:nvGrpSpPr>
        <p:grpSpPr>
          <a:xfrm>
            <a:off x="834431" y="2368652"/>
            <a:ext cx="3361722" cy="1099606"/>
            <a:chOff x="802845" y="-150673"/>
            <a:chExt cx="3361722" cy="1099606"/>
          </a:xfrm>
        </p:grpSpPr>
        <p:sp>
          <p:nvSpPr>
            <p:cNvPr id="68" name="TextBox 67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69" name="TextBox 68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72" name="TextBox 71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p38</a:t>
              </a:r>
              <a:endParaRPr lang="en-GB" sz="1200" dirty="0"/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6179940" y="3567657"/>
            <a:ext cx="730215" cy="384578"/>
            <a:chOff x="6156998" y="1122195"/>
            <a:chExt cx="730215" cy="384578"/>
          </a:xfrm>
        </p:grpSpPr>
        <p:sp>
          <p:nvSpPr>
            <p:cNvPr id="78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79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80" name="Straight Connector 79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" name="TextBox 166"/>
          <p:cNvSpPr txBox="1">
            <a:spLocks noChangeArrowheads="1"/>
          </p:cNvSpPr>
          <p:nvPr/>
        </p:nvSpPr>
        <p:spPr bwMode="auto">
          <a:xfrm>
            <a:off x="5310253" y="3648061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pic>
        <p:nvPicPr>
          <p:cNvPr id="83" name="Picture 11"/>
          <p:cNvPicPr preferRelativeResize="0"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5" y="331719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4" name="Picture 13"/>
          <p:cNvPicPr preferRelativeResize="0">
            <a:picLocks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9960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14"/>
          <p:cNvPicPr preferRelativeResize="0"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4507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15"/>
          <p:cNvPicPr preferRelativeResize="0">
            <a:picLocks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0544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16"/>
          <p:cNvPicPr preferRelativeResize="0">
            <a:picLocks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9887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17"/>
          <p:cNvPicPr preferRelativeResize="0">
            <a:picLocks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6692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18"/>
          <p:cNvPicPr preferRelativeResize="0">
            <a:picLocks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4461" y="331719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19"/>
          <p:cNvPicPr preferRelativeResize="0">
            <a:picLocks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3867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91" name="Group 90"/>
          <p:cNvGrpSpPr/>
          <p:nvPr/>
        </p:nvGrpSpPr>
        <p:grpSpPr>
          <a:xfrm>
            <a:off x="4010512" y="2352855"/>
            <a:ext cx="3435560" cy="1111631"/>
            <a:chOff x="3914896" y="-135184"/>
            <a:chExt cx="3435560" cy="1111631"/>
          </a:xfrm>
        </p:grpSpPr>
        <p:sp>
          <p:nvSpPr>
            <p:cNvPr id="92" name="TextBox 91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p38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99" name="TextBox 98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100" name="TextBox 99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101" name="Picture 2"/>
          <p:cNvPicPr preferRelativeResize="0"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9620" y="331005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" name="Picture 3"/>
          <p:cNvPicPr preferRelativeResize="0"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8134" y="331502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4"/>
          <p:cNvPicPr preferRelativeResize="0">
            <a:picLocks noChangeArrowheads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1288" y="332307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6"/>
          <p:cNvPicPr preferRelativeResize="0">
            <a:picLocks noChangeArrowheads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7970" y="331934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" name="Picture 7"/>
          <p:cNvPicPr preferRelativeResize="0">
            <a:picLocks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2773" y="331807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" name="Picture 8"/>
          <p:cNvPicPr preferRelativeResize="0">
            <a:picLocks noChangeArrowheads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4277" y="331502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" name="Picture 9"/>
          <p:cNvPicPr preferRelativeResize="0"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3133" y="331005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" name="Picture 10"/>
          <p:cNvPicPr preferRelativeResize="0">
            <a:picLocks noChangeArrowheads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0093" y="331571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9" name="TextBox 108"/>
          <p:cNvSpPr txBox="1"/>
          <p:nvPr/>
        </p:nvSpPr>
        <p:spPr>
          <a:xfrm>
            <a:off x="728351" y="3475508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Left Ventricle</a:t>
            </a:r>
            <a:endParaRPr lang="en-US" sz="1000" dirty="0"/>
          </a:p>
        </p:txBody>
      </p:sp>
      <p:sp>
        <p:nvSpPr>
          <p:cNvPr id="110" name="TextBox 109"/>
          <p:cNvSpPr txBox="1"/>
          <p:nvPr/>
        </p:nvSpPr>
        <p:spPr>
          <a:xfrm>
            <a:off x="4043592" y="3474696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Left Ventricle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636110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31</Words>
  <Application>Microsoft Office PowerPoint</Application>
  <PresentationFormat>On-screen Show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yola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pinceti</dc:creator>
  <cp:lastModifiedBy>Elpinceti</cp:lastModifiedBy>
  <cp:revision>5</cp:revision>
  <dcterms:created xsi:type="dcterms:W3CDTF">2016-04-22T00:41:58Z</dcterms:created>
  <dcterms:modified xsi:type="dcterms:W3CDTF">2016-05-23T16:44:08Z</dcterms:modified>
</cp:coreProperties>
</file>